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A3E1B6-9103-7C6B-25CB-AA418A7986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8433CB3-D1E1-A8EC-0F4B-60FCDE8300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8758B95-5F00-A21A-5CEB-1551B85A8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F71F88-D6DE-AFFA-F704-09A4FF86D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959A43-AB37-F01C-3046-718574F3F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660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5B5CBF-F79D-5D94-5C6B-4CCDE8212A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A6C314A-70FA-2B75-2148-CE73F683C8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0E2B69-EF03-0213-4951-298D6DE08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C755964-A9E4-5714-DF3E-6135387AC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19256D-26A0-827C-43D7-07F3E00C5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5416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3E66019-F323-EB06-D92C-3AFD819A71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2934414-B831-3D99-1FFF-337BB70F44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356FA7-2EF8-CF9A-A9DF-08C1278B9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CD2E9B2-1769-E5B8-73CB-48ABB4C8D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D76E47B-CB98-C28D-B13A-78AD94B4E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8159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442C3BF-CBAA-83F3-92AB-BA70F0DD9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4629075-CCB2-782D-E0E7-AD08866996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1A980BD-5625-8758-43B4-B4803A664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562461B-76B2-2E03-6DFF-6BC87EEE4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D214E60-0D10-7D03-50D4-15F2A8DB8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8305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147049-EF74-3DD9-BCBA-7F89A8C952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2C1370-03FD-4C21-607D-A44713ECA4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9377233-E49F-0B2E-C66C-A05580F5E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54D4B8F-A221-212A-AC71-856743F03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B3E1978-1D51-2EA7-AC9F-44B1EED5B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181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EB2D4F-3CFC-4C19-F2EC-4AE083D52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9084500-545B-384A-35D0-E118F5D412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A10CD8D-072C-A28D-C1E2-D9D97E9BD6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7F32DA4-0777-FA44-18FF-7B7E1272A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968F11C-A441-7829-A93A-A4E0442D4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8F13601-03E5-7D91-2DE1-22EA2F967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6427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730DF1-E665-7088-6A1C-78E0C7E1CB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ECD262C-5241-DE04-2A97-1FFAA5BF60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911BF2A-3934-67EA-8E36-E1220B96C1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910A74E-E404-2759-0A2E-960DEC0B51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15FA1AC-FAE3-4052-D170-27703EACC9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4660670-8DDF-242E-5973-74C0CA340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05C15B6-1940-FBF6-9A4C-FB3D201E5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CBDF304-3148-2EBF-1781-F23E4AABB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7244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71F9C6-6C02-9720-C4A9-06101AAC6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341AAA3-D2E7-4B50-6551-28E65E042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56199E4-2EDC-29F0-C0D1-354634D15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0550A9A-A483-9721-DA32-167A9000D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7510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4400D7B-F5A5-4E94-0849-1511305E2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4AB90DC-54DB-470E-F141-E87F4DBA3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59CC49E-28D1-F42D-C378-E7C294425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1975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D30BB-1CB3-8E42-8D7E-8E528D5DC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F4B6073-FC55-B170-A313-D1ABFCE9B1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A06D4BF-1B14-EBCE-5847-FF91A3F22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4F6F808-0CF5-C347-66E8-63435E374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BA92F41-7237-84E3-A204-063072AD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C69D3D6-28E8-3D18-04C9-59067B70F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2614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88F5FE-9510-A7F4-AA95-A2A00770C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8DC717E-79B3-3FAE-ED6E-06AFC9E10F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D97DE0A-3B72-EF7B-F5A0-F3EB1DD267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8CF295F-B43E-98E0-FD89-40B4F034B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B9B9D84-FFC7-3AB6-4EF8-1EC67CA18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0BBEEFD-3974-1CB7-15A1-7EE74D202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6302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D96F412-DF46-994C-E2CF-936F04D62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023F226-ADE2-2D87-AF81-51FD65D21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2F37B81-A9DA-4032-9067-0F7B76C222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EAE74-FF93-4F25-8910-3C53C3F34CE4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175310-6EFC-8978-1233-6CF8B5259F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696039-BB10-9529-0005-04242B11A4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DA254-94D6-41D0-96B5-2501C17893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6842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07651C8F-3559-2910-82BE-4B64FDF1C65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5525" y="280432"/>
            <a:ext cx="3747375" cy="1483839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ACE59191-9E10-65F6-799F-DCC1F7E9E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12" t="29834" r="6150"/>
          <a:stretch/>
        </p:blipFill>
        <p:spPr>
          <a:xfrm>
            <a:off x="1580718" y="1965510"/>
            <a:ext cx="2759635" cy="1176033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51E1742A-828E-950A-A577-2B85CB75A20D}"/>
              </a:ext>
            </a:extLst>
          </p:cNvPr>
          <p:cNvSpPr txBox="1"/>
          <p:nvPr/>
        </p:nvSpPr>
        <p:spPr>
          <a:xfrm>
            <a:off x="1227736" y="95766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8ABF93E6-AB40-F67A-9BCB-F2FB1C0A49F3}"/>
              </a:ext>
            </a:extLst>
          </p:cNvPr>
          <p:cNvSpPr txBox="1"/>
          <p:nvPr/>
        </p:nvSpPr>
        <p:spPr>
          <a:xfrm>
            <a:off x="1222126" y="157542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A5D34E7-5254-AF12-1DB7-A82E9A46F813}"/>
              </a:ext>
            </a:extLst>
          </p:cNvPr>
          <p:cNvSpPr txBox="1"/>
          <p:nvPr/>
        </p:nvSpPr>
        <p:spPr>
          <a:xfrm>
            <a:off x="1171326" y="5269964"/>
            <a:ext cx="8531474" cy="15334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1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</a:t>
            </a:r>
            <a:r>
              <a:rPr lang="fr-FR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man tissue </a:t>
            </a:r>
            <a:r>
              <a:rPr lang="fr-FR" sz="11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</a:t>
            </a:r>
            <a:r>
              <a:rPr lang="fr-FR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ection</a:t>
            </a:r>
            <a:r>
              <a:rPr lang="fr-FR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ematic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and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ctur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) of a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ypical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gical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ection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ndl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e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skin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cinoma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gical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ection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ndl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de of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re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rts :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sion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L)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tself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middle of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ndl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ilesional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PL) part of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fety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gery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rgin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oun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sion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ndle-tip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 non-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sional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L) skin sites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move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ow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amles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uture. Skin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llow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k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move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omic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ing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2 mm-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meter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unch. (c)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ctures of two surgical spindles featuring punches taken for transcriptomic analysis on each of the three parts of the spindle : L, lesion (carcinoma), PL,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ilesion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safety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gin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NL, non-lesion (healthy skin taken from one of the spindle tips). (d) H&amp;E-stained histological section of human skin. Green arrows point at 2 mm-punch made in patients skin for transcriptomic analysis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per, punch is taken from a basal cell carcinoma, not included in the current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criptomic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udy (L site); bottom the punch is taken on a healthy (NL) skin site, red blood cells fill in the hole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023A0E71-F35E-887D-0C49-C33F514A877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925" y="3297358"/>
            <a:ext cx="4014075" cy="2018186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9CDC8392-C1D2-2F3E-4484-AC5D5EA5F163}"/>
              </a:ext>
            </a:extLst>
          </p:cNvPr>
          <p:cNvSpPr txBox="1"/>
          <p:nvPr/>
        </p:nvSpPr>
        <p:spPr>
          <a:xfrm>
            <a:off x="1227736" y="3164829"/>
            <a:ext cx="352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c.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9B47F399-D0A0-D50B-8A33-C95A3153947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92"/>
          <a:stretch/>
        </p:blipFill>
        <p:spPr bwMode="auto">
          <a:xfrm>
            <a:off x="6480494" y="280432"/>
            <a:ext cx="3066415" cy="18859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0BBA930D-88A6-CD7D-50A2-D8C96EF3B28B}"/>
              </a:ext>
            </a:extLst>
          </p:cNvPr>
          <p:cNvSpPr txBox="1"/>
          <p:nvPr/>
        </p:nvSpPr>
        <p:spPr>
          <a:xfrm>
            <a:off x="6000075" y="9576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d.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2790D1D3-727E-201F-F736-E4718E279F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80493" y="2731643"/>
            <a:ext cx="3066415" cy="2136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26509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0</TotalTime>
  <Words>235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3</cp:revision>
  <dcterms:created xsi:type="dcterms:W3CDTF">2023-01-25T15:24:38Z</dcterms:created>
  <dcterms:modified xsi:type="dcterms:W3CDTF">2023-02-21T14:21:48Z</dcterms:modified>
</cp:coreProperties>
</file>